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  <p:sldId id="27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2" d="100"/>
          <a:sy n="52" d="100"/>
        </p:scale>
        <p:origin x="231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0599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3998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7014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2436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2739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9471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907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8020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973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7190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2173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62F95-C77C-43A3-B2F3-68CFFA35DAC9}" type="datetimeFigureOut">
              <a:rPr lang="es-ES" smtClean="0"/>
              <a:t>10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0077C-863E-4AB2-AC2F-F7411426F8E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0432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CuadroTexto 21"/>
          <p:cNvSpPr txBox="1"/>
          <p:nvPr/>
        </p:nvSpPr>
        <p:spPr>
          <a:xfrm>
            <a:off x="335787" y="353999"/>
            <a:ext cx="1349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1 (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part</a:t>
            </a:r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1)</a:t>
            </a:r>
            <a:endParaRPr lang="es-ES" sz="11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705850" y="994079"/>
            <a:ext cx="1349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CeD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CuadroTexto 23"/>
          <p:cNvSpPr txBox="1"/>
          <p:nvPr/>
        </p:nvSpPr>
        <p:spPr>
          <a:xfrm>
            <a:off x="2706390" y="994079"/>
            <a:ext cx="1349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SLE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466111" y="3064197"/>
            <a:ext cx="1828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RA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CuadroTexto 25"/>
          <p:cNvSpPr txBox="1"/>
          <p:nvPr/>
        </p:nvSpPr>
        <p:spPr>
          <a:xfrm>
            <a:off x="2706390" y="3064197"/>
            <a:ext cx="1349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MS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CuadroTexto 29"/>
          <p:cNvSpPr txBox="1"/>
          <p:nvPr/>
        </p:nvSpPr>
        <p:spPr>
          <a:xfrm>
            <a:off x="353204" y="689282"/>
            <a:ext cx="23116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a) 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Autoimmune</a:t>
            </a:r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diseases</a:t>
            </a:r>
            <a:endParaRPr lang="es-ES" sz="11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CuadroTexto 39"/>
          <p:cNvSpPr txBox="1"/>
          <p:nvPr/>
        </p:nvSpPr>
        <p:spPr>
          <a:xfrm>
            <a:off x="4784737" y="1000934"/>
            <a:ext cx="15394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SS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" name="Imagen 4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356" y="1236755"/>
            <a:ext cx="1792310" cy="1792310"/>
          </a:xfrm>
          <a:prstGeom prst="rect">
            <a:avLst/>
          </a:prstGeom>
        </p:spPr>
      </p:pic>
      <p:pic>
        <p:nvPicPr>
          <p:cNvPr id="42" name="Imagen 4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4896" y="1171441"/>
            <a:ext cx="1792310" cy="1792310"/>
          </a:xfrm>
          <a:prstGeom prst="rect">
            <a:avLst/>
          </a:prstGeom>
        </p:spPr>
      </p:pic>
      <p:pic>
        <p:nvPicPr>
          <p:cNvPr id="43" name="Imagen 4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8298" y="1226983"/>
            <a:ext cx="1792310" cy="1792310"/>
          </a:xfrm>
          <a:prstGeom prst="rect">
            <a:avLst/>
          </a:prstGeom>
        </p:spPr>
      </p:pic>
      <p:pic>
        <p:nvPicPr>
          <p:cNvPr id="44" name="Imagen 4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356" y="3332747"/>
            <a:ext cx="1792310" cy="1792310"/>
          </a:xfrm>
          <a:prstGeom prst="rect">
            <a:avLst/>
          </a:prstGeom>
        </p:spPr>
      </p:pic>
      <p:pic>
        <p:nvPicPr>
          <p:cNvPr id="45" name="Imagen 4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4896" y="3332747"/>
            <a:ext cx="1792310" cy="1792310"/>
          </a:xfrm>
          <a:prstGeom prst="rect">
            <a:avLst/>
          </a:prstGeom>
        </p:spPr>
      </p:pic>
      <p:sp>
        <p:nvSpPr>
          <p:cNvPr id="46" name="CuadroTexto 45"/>
          <p:cNvSpPr txBox="1"/>
          <p:nvPr/>
        </p:nvSpPr>
        <p:spPr>
          <a:xfrm>
            <a:off x="705850" y="5648130"/>
            <a:ext cx="1349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Weight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CuadroTexto 46"/>
          <p:cNvSpPr txBox="1"/>
          <p:nvPr/>
        </p:nvSpPr>
        <p:spPr>
          <a:xfrm>
            <a:off x="2706390" y="5648130"/>
            <a:ext cx="1349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Height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CuadroTexto 47"/>
          <p:cNvSpPr txBox="1"/>
          <p:nvPr/>
        </p:nvSpPr>
        <p:spPr>
          <a:xfrm>
            <a:off x="466111" y="7718249"/>
            <a:ext cx="1828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BMI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CuadroTexto 48"/>
          <p:cNvSpPr txBox="1"/>
          <p:nvPr/>
        </p:nvSpPr>
        <p:spPr>
          <a:xfrm>
            <a:off x="2706390" y="7718249"/>
            <a:ext cx="1349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Waist</a:t>
            </a:r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-to-hip ratio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CuadroTexto 49"/>
          <p:cNvSpPr txBox="1"/>
          <p:nvPr/>
        </p:nvSpPr>
        <p:spPr>
          <a:xfrm>
            <a:off x="364924" y="5343333"/>
            <a:ext cx="23116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</a:t>
            </a:r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) 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Anthropometric</a:t>
            </a:r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traits</a:t>
            </a:r>
            <a:endParaRPr lang="es-ES" sz="11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5" name="Imagen 5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356" y="7965166"/>
            <a:ext cx="1792310" cy="1792310"/>
          </a:xfrm>
          <a:prstGeom prst="rect">
            <a:avLst/>
          </a:prstGeom>
        </p:spPr>
      </p:pic>
      <p:pic>
        <p:nvPicPr>
          <p:cNvPr id="56" name="Imagen 5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4896" y="7925978"/>
            <a:ext cx="1792310" cy="1792310"/>
          </a:xfrm>
          <a:prstGeom prst="rect">
            <a:avLst/>
          </a:prstGeom>
        </p:spPr>
      </p:pic>
      <p:pic>
        <p:nvPicPr>
          <p:cNvPr id="57" name="Imagen 5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5011" y="5891432"/>
            <a:ext cx="1792310" cy="1792310"/>
          </a:xfrm>
          <a:prstGeom prst="rect">
            <a:avLst/>
          </a:prstGeom>
        </p:spPr>
      </p:pic>
      <p:pic>
        <p:nvPicPr>
          <p:cNvPr id="58" name="Imagen 5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36" y="5865306"/>
            <a:ext cx="1792310" cy="17923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66642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n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2983" y="3772716"/>
            <a:ext cx="1792310" cy="1792310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028" y="3772716"/>
            <a:ext cx="1792310" cy="1792310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1708" y="1432750"/>
            <a:ext cx="1792310" cy="1792310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028" y="1432750"/>
            <a:ext cx="1792310" cy="1792310"/>
          </a:xfrm>
          <a:prstGeom prst="rect">
            <a:avLst/>
          </a:prstGeom>
        </p:spPr>
      </p:pic>
      <p:pic>
        <p:nvPicPr>
          <p:cNvPr id="21" name="Imagen 2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5021" y="3751208"/>
            <a:ext cx="1839696" cy="1839696"/>
          </a:xfrm>
          <a:prstGeom prst="rect">
            <a:avLst/>
          </a:prstGeom>
        </p:spPr>
      </p:pic>
      <p:sp>
        <p:nvSpPr>
          <p:cNvPr id="22" name="CuadroTexto 21"/>
          <p:cNvSpPr txBox="1"/>
          <p:nvPr/>
        </p:nvSpPr>
        <p:spPr>
          <a:xfrm>
            <a:off x="335787" y="353999"/>
            <a:ext cx="1349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1 (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part</a:t>
            </a:r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2)</a:t>
            </a:r>
            <a:endParaRPr lang="es-ES" sz="11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771522" y="994079"/>
            <a:ext cx="13493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eproductive</a:t>
            </a:r>
            <a:r>
              <a:rPr lang="es-ES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hormone </a:t>
            </a:r>
            <a:r>
              <a:rPr lang="es-ES" sz="11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levels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CuadroTexto 23"/>
          <p:cNvSpPr txBox="1"/>
          <p:nvPr/>
        </p:nvSpPr>
        <p:spPr>
          <a:xfrm>
            <a:off x="2783202" y="994079"/>
            <a:ext cx="13493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AMH</a:t>
            </a:r>
          </a:p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levels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771522" y="3327972"/>
            <a:ext cx="13493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Age</a:t>
            </a:r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at</a:t>
            </a:r>
          </a:p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menarche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CuadroTexto 25"/>
          <p:cNvSpPr txBox="1"/>
          <p:nvPr/>
        </p:nvSpPr>
        <p:spPr>
          <a:xfrm>
            <a:off x="2783202" y="3327972"/>
            <a:ext cx="13493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Age</a:t>
            </a:r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at</a:t>
            </a:r>
          </a:p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menopause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/>
          <p:cNvSpPr txBox="1"/>
          <p:nvPr/>
        </p:nvSpPr>
        <p:spPr>
          <a:xfrm>
            <a:off x="4814477" y="3327972"/>
            <a:ext cx="13493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Length</a:t>
            </a:r>
            <a:r>
              <a:rPr lang="es-ES" sz="1100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of menstrual </a:t>
            </a:r>
            <a:r>
              <a:rPr lang="es-ES" sz="1100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cycle</a:t>
            </a:r>
            <a:endParaRPr lang="es-ES" sz="11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CuadroTexto 29"/>
          <p:cNvSpPr txBox="1"/>
          <p:nvPr/>
        </p:nvSpPr>
        <p:spPr>
          <a:xfrm>
            <a:off x="353204" y="689282"/>
            <a:ext cx="23116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c) 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Female</a:t>
            </a:r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reproductive</a:t>
            </a:r>
            <a:r>
              <a:rPr lang="es-ES" sz="1100" b="1" dirty="0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 smtClean="0">
                <a:latin typeface="Palatino Linotype" panose="02040502050505030304" pitchFamily="18" charset="0"/>
                <a:cs typeface="Times New Roman" panose="02020603050405020304" pitchFamily="18" charset="0"/>
              </a:rPr>
              <a:t>traits</a:t>
            </a:r>
            <a:endParaRPr lang="es-ES" sz="11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4335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1</TotalTime>
  <Words>50</Words>
  <Application>Microsoft Office PowerPoint</Application>
  <PresentationFormat>A4 (210 x 297 mm)</PresentationFormat>
  <Paragraphs>22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Tema de Office</vt:lpstr>
      <vt:lpstr>Presentación de PowerPoint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aritazelaia et al., 2020, Life</dc:title>
  <dc:creator>IRAIA GARCIA</dc:creator>
  <cp:lastModifiedBy>IRAIA GARCIA</cp:lastModifiedBy>
  <cp:revision>41</cp:revision>
  <dcterms:created xsi:type="dcterms:W3CDTF">2020-11-24T11:01:43Z</dcterms:created>
  <dcterms:modified xsi:type="dcterms:W3CDTF">2020-12-10T11:10:19Z</dcterms:modified>
</cp:coreProperties>
</file>